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9" autoAdjust="0"/>
    <p:restoredTop sz="94291" autoAdjust="0"/>
  </p:normalViewPr>
  <p:slideViewPr>
    <p:cSldViewPr snapToGrid="0">
      <p:cViewPr varScale="1">
        <p:scale>
          <a:sx n="81" d="100"/>
          <a:sy n="81" d="100"/>
        </p:scale>
        <p:origin x="2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394D82-4CA9-4147-83CA-854CBC9BB71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E4DFAA-16F2-4992-B3EB-E39BF47ADE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779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9950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3174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27854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89666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07954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98843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52051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8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6FFB7-FEF1-4753-A200-8AA6CF036D6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27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029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58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013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920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282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975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40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100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021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055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746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93198-E6F7-4557-B836-9EF7575DBD55}" type="datetimeFigureOut">
              <a:rPr lang="en-US" smtClean="0"/>
              <a:t>10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A78A8-D7B5-45D8-858A-4149A208FC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34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13" Type="http://schemas.openxmlformats.org/officeDocument/2006/relationships/image" Target="../media/image19.tiff"/><Relationship Id="rId3" Type="http://schemas.openxmlformats.org/officeDocument/2006/relationships/image" Target="../media/image9.png"/><Relationship Id="rId7" Type="http://schemas.openxmlformats.org/officeDocument/2006/relationships/image" Target="../media/image13.tiff"/><Relationship Id="rId12" Type="http://schemas.openxmlformats.org/officeDocument/2006/relationships/image" Target="../media/image18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11" Type="http://schemas.openxmlformats.org/officeDocument/2006/relationships/image" Target="../media/image17.tiff"/><Relationship Id="rId5" Type="http://schemas.openxmlformats.org/officeDocument/2006/relationships/image" Target="../media/image11.jpeg"/><Relationship Id="rId10" Type="http://schemas.openxmlformats.org/officeDocument/2006/relationships/image" Target="../media/image16.tiff"/><Relationship Id="rId4" Type="http://schemas.openxmlformats.org/officeDocument/2006/relationships/image" Target="../media/image10.jpeg"/><Relationship Id="rId9" Type="http://schemas.openxmlformats.org/officeDocument/2006/relationships/image" Target="../media/image15.tiff"/><Relationship Id="rId14" Type="http://schemas.openxmlformats.org/officeDocument/2006/relationships/image" Target="../media/image20.tiff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29.png"/><Relationship Id="rId3" Type="http://schemas.openxmlformats.org/officeDocument/2006/relationships/image" Target="../media/image21.jpeg"/><Relationship Id="rId7" Type="http://schemas.openxmlformats.org/officeDocument/2006/relationships/image" Target="../media/image25.png"/><Relationship Id="rId12" Type="http://schemas.microsoft.com/office/2007/relationships/hdphoto" Target="../media/hdphoto2.wdp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jpeg"/><Relationship Id="rId11" Type="http://schemas.openxmlformats.org/officeDocument/2006/relationships/image" Target="../media/image28.png"/><Relationship Id="rId5" Type="http://schemas.openxmlformats.org/officeDocument/2006/relationships/image" Target="../media/image23.jpeg"/><Relationship Id="rId10" Type="http://schemas.openxmlformats.org/officeDocument/2006/relationships/image" Target="../media/image27.tiff"/><Relationship Id="rId4" Type="http://schemas.openxmlformats.org/officeDocument/2006/relationships/image" Target="../media/image22.jpeg"/><Relationship Id="rId9" Type="http://schemas.openxmlformats.org/officeDocument/2006/relationships/image" Target="../media/image26.png"/><Relationship Id="rId14" Type="http://schemas.microsoft.com/office/2007/relationships/hdphoto" Target="../media/hdphoto3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7" Type="http://schemas.openxmlformats.org/officeDocument/2006/relationships/image" Target="../media/image32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microsoft.com/office/2007/relationships/hdphoto" Target="../media/hdphoto5.wdp"/><Relationship Id="rId5" Type="http://schemas.openxmlformats.org/officeDocument/2006/relationships/image" Target="../media/image31.png"/><Relationship Id="rId4" Type="http://schemas.microsoft.com/office/2007/relationships/hdphoto" Target="../media/hdphoto4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523E8F3-FED0-48EC-B358-13A7D8AF8A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8879" y="1072971"/>
            <a:ext cx="5029200" cy="3012732"/>
          </a:xfrm>
          <a:prstGeom prst="rect">
            <a:avLst/>
          </a:prstGeo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413FC8F5-1AAA-405E-BC35-72B64A6375FD}"/>
              </a:ext>
            </a:extLst>
          </p:cNvPr>
          <p:cNvGrpSpPr/>
          <p:nvPr/>
        </p:nvGrpSpPr>
        <p:grpSpPr>
          <a:xfrm>
            <a:off x="2657340" y="3909694"/>
            <a:ext cx="4381206" cy="1421295"/>
            <a:chOff x="7761538" y="3713874"/>
            <a:chExt cx="4381206" cy="142129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13AFABA-A0E9-462E-9845-A74FE74C1B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04" t="40273" r="39168" b="46823"/>
            <a:stretch/>
          </p:blipFill>
          <p:spPr>
            <a:xfrm>
              <a:off x="8526447" y="4083266"/>
              <a:ext cx="3072523" cy="64275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38EE8A1-EBF0-4E1E-9CDA-DD6BB1ED5093}"/>
                </a:ext>
              </a:extLst>
            </p:cNvPr>
            <p:cNvSpPr txBox="1"/>
            <p:nvPr/>
          </p:nvSpPr>
          <p:spPr>
            <a:xfrm>
              <a:off x="7761538" y="4094923"/>
              <a:ext cx="78611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WW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S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19622F2-5561-43E2-B420-7FC664560194}"/>
                </a:ext>
              </a:extLst>
            </p:cNvPr>
            <p:cNvSpPr txBox="1"/>
            <p:nvPr/>
          </p:nvSpPr>
          <p:spPr>
            <a:xfrm>
              <a:off x="8866469" y="3717834"/>
              <a:ext cx="2370451" cy="3770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WT                     5T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DFCF5B4-788B-41F6-AA10-112A9AB20C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498" t="39967" r="32009" b="37828"/>
            <a:stretch/>
          </p:blipFill>
          <p:spPr>
            <a:xfrm>
              <a:off x="11675605" y="3713874"/>
              <a:ext cx="467139" cy="1421295"/>
            </a:xfrm>
            <a:prstGeom prst="rect">
              <a:avLst/>
            </a:prstGeom>
          </p:spPr>
        </p:pic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6EEE263-A41C-475C-9C0B-85B53C3AB409}"/>
              </a:ext>
            </a:extLst>
          </p:cNvPr>
          <p:cNvSpPr txBox="1"/>
          <p:nvPr/>
        </p:nvSpPr>
        <p:spPr>
          <a:xfrm>
            <a:off x="2613012" y="980548"/>
            <a:ext cx="44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16B1A7-3611-43F8-A6E6-A99B298B8766}"/>
              </a:ext>
            </a:extLst>
          </p:cNvPr>
          <p:cNvSpPr txBox="1"/>
          <p:nvPr/>
        </p:nvSpPr>
        <p:spPr>
          <a:xfrm>
            <a:off x="2607213" y="3673414"/>
            <a:ext cx="44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20104" y="4620341"/>
            <a:ext cx="512618" cy="369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*</a:t>
            </a:r>
          </a:p>
        </p:txBody>
      </p:sp>
      <p:sp>
        <p:nvSpPr>
          <p:cNvPr id="12" name="Rectangle 11"/>
          <p:cNvSpPr/>
          <p:nvPr/>
        </p:nvSpPr>
        <p:spPr>
          <a:xfrm>
            <a:off x="-53708" y="6514127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511910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7A99FC-5911-4A23-9938-5DB36C8BBC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8440" y="719342"/>
            <a:ext cx="6858000" cy="581186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-53708" y="6514127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5062145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342C072-FD0C-44CF-9D2D-7141B8A2CB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8060" y="1600200"/>
            <a:ext cx="6555879" cy="36576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-53708" y="6514127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909261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130B3632-DAD3-4FEE-BFFC-C8FA43F8EDD9}"/>
              </a:ext>
            </a:extLst>
          </p:cNvPr>
          <p:cNvGrpSpPr/>
          <p:nvPr/>
        </p:nvGrpSpPr>
        <p:grpSpPr>
          <a:xfrm>
            <a:off x="1308060" y="1111999"/>
            <a:ext cx="3693409" cy="4231802"/>
            <a:chOff x="6580172" y="3781100"/>
            <a:chExt cx="3693409" cy="4231802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F387CF5-B68A-4D34-866D-DB6FC8CD0ED4}"/>
                </a:ext>
              </a:extLst>
            </p:cNvPr>
            <p:cNvSpPr txBox="1"/>
            <p:nvPr/>
          </p:nvSpPr>
          <p:spPr>
            <a:xfrm>
              <a:off x="6580172" y="3937370"/>
              <a:ext cx="61953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8192ADD-2021-4AE4-B8F6-ECAE2D1946CF}"/>
                </a:ext>
              </a:extLst>
            </p:cNvPr>
            <p:cNvSpPr txBox="1"/>
            <p:nvPr/>
          </p:nvSpPr>
          <p:spPr>
            <a:xfrm>
              <a:off x="6580172" y="5836146"/>
              <a:ext cx="61953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AD9B9CB3-BB7D-47C3-8D63-572F039455F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40157" y="3781100"/>
              <a:ext cx="3433424" cy="228600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DF6CF5BF-B418-4A95-B3FE-1DB09E97767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840157" y="5726902"/>
              <a:ext cx="3433424" cy="2286000"/>
            </a:xfrm>
            <a:prstGeom prst="rect">
              <a:avLst/>
            </a:prstGeom>
          </p:spPr>
        </p:pic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63A074B-5E3E-4DC1-88A7-C4E42839C3AE}"/>
              </a:ext>
            </a:extLst>
          </p:cNvPr>
          <p:cNvGrpSpPr/>
          <p:nvPr/>
        </p:nvGrpSpPr>
        <p:grpSpPr>
          <a:xfrm>
            <a:off x="5001469" y="1111999"/>
            <a:ext cx="3747779" cy="4219653"/>
            <a:chOff x="6580172" y="-150548"/>
            <a:chExt cx="3676412" cy="4219653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A1D1FFE-14E4-4986-A60B-4C77856C59CC}"/>
                </a:ext>
              </a:extLst>
            </p:cNvPr>
            <p:cNvSpPr txBox="1"/>
            <p:nvPr/>
          </p:nvSpPr>
          <p:spPr>
            <a:xfrm>
              <a:off x="6580172" y="-2486"/>
              <a:ext cx="61953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C5FD868-FF69-4247-99EB-CCC2443524D6}"/>
                </a:ext>
              </a:extLst>
            </p:cNvPr>
            <p:cNvSpPr txBox="1"/>
            <p:nvPr/>
          </p:nvSpPr>
          <p:spPr>
            <a:xfrm>
              <a:off x="6580172" y="1844188"/>
              <a:ext cx="61953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2400" b="1" noProof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6561D7F3-8EC2-4B0F-BE4E-31A770E922A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57153" y="-150548"/>
              <a:ext cx="3399431" cy="228600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7A7732AB-29E7-483A-A0D2-B3D3A746D95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823506" y="1795413"/>
              <a:ext cx="3410712" cy="2273692"/>
            </a:xfrm>
            <a:prstGeom prst="rect">
              <a:avLst/>
            </a:prstGeom>
          </p:spPr>
        </p:pic>
      </p:grpSp>
      <p:sp>
        <p:nvSpPr>
          <p:cNvPr id="12" name="Rectangle 11"/>
          <p:cNvSpPr/>
          <p:nvPr/>
        </p:nvSpPr>
        <p:spPr>
          <a:xfrm>
            <a:off x="-53708" y="6514127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3500619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FA199FB-A647-4AA7-B159-AC3BAA0664FD}"/>
              </a:ext>
            </a:extLst>
          </p:cNvPr>
          <p:cNvGrpSpPr/>
          <p:nvPr/>
        </p:nvGrpSpPr>
        <p:grpSpPr>
          <a:xfrm>
            <a:off x="7804225" y="639032"/>
            <a:ext cx="3303221" cy="4892242"/>
            <a:chOff x="4164380" y="372702"/>
            <a:chExt cx="3303221" cy="4892242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61" t="17593" r="1679" b="15010"/>
            <a:stretch/>
          </p:blipFill>
          <p:spPr>
            <a:xfrm>
              <a:off x="5152650" y="1255796"/>
              <a:ext cx="2300663" cy="914400"/>
            </a:xfrm>
            <a:prstGeom prst="rect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26" name="Flowchart: Extract 25"/>
            <p:cNvSpPr/>
            <p:nvPr/>
          </p:nvSpPr>
          <p:spPr>
            <a:xfrm rot="16200000" flipH="1">
              <a:off x="6207057" y="1707330"/>
              <a:ext cx="59635" cy="112196"/>
            </a:xfrm>
            <a:prstGeom prst="flowChartExtract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lowchart: Extract 26"/>
            <p:cNvSpPr/>
            <p:nvPr/>
          </p:nvSpPr>
          <p:spPr>
            <a:xfrm rot="5400000">
              <a:off x="5057187" y="1443685"/>
              <a:ext cx="59635" cy="112196"/>
            </a:xfrm>
            <a:prstGeom prst="flowChartExtract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9310695">
              <a:off x="5035654" y="997478"/>
              <a:ext cx="4010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217670" y="720336"/>
              <a:ext cx="40588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5075787" y="720336"/>
              <a:ext cx="1145057" cy="6370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4164380" y="748828"/>
              <a:ext cx="924805" cy="530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20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 fusion</a:t>
              </a:r>
            </a:p>
            <a:p>
              <a:pPr defTabSz="342900"/>
              <a:endParaRPr lang="en-US" sz="45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defTabSz="342900"/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 fusion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9310695">
              <a:off x="5238177" y="994902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5065676" y="997335"/>
              <a:ext cx="542108" cy="4247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 rot="19310695">
              <a:off x="5581342" y="1012229"/>
              <a:ext cx="4010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724352" y="724026"/>
              <a:ext cx="434734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l-GR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9310695">
              <a:off x="5772803" y="1004573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37" name="Straight Connector 36"/>
            <p:cNvCxnSpPr/>
            <p:nvPr/>
          </p:nvCxnSpPr>
          <p:spPr>
            <a:xfrm>
              <a:off x="5644546" y="1001025"/>
              <a:ext cx="542108" cy="4247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 rot="19310695">
              <a:off x="6218286" y="1008312"/>
              <a:ext cx="4010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402340" y="731170"/>
              <a:ext cx="40588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9310695">
              <a:off x="6431870" y="1000656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6259369" y="1008169"/>
              <a:ext cx="542108" cy="4247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 rot="19310695">
              <a:off x="6730790" y="1002743"/>
              <a:ext cx="40107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909021" y="734860"/>
              <a:ext cx="434734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l-GR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 rot="19310695">
              <a:off x="6922252" y="1005247"/>
              <a:ext cx="4459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0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45" name="Straight Connector 44"/>
            <p:cNvCxnSpPr>
              <a:cxnSpLocks/>
            </p:cNvCxnSpPr>
            <p:nvPr/>
          </p:nvCxnSpPr>
          <p:spPr>
            <a:xfrm>
              <a:off x="6838239" y="1011859"/>
              <a:ext cx="542108" cy="4247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5401998" y="372702"/>
              <a:ext cx="598241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put</a:t>
              </a:r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6280543" y="731170"/>
              <a:ext cx="1145057" cy="6370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6606753" y="383536"/>
              <a:ext cx="569387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IP</a:t>
              </a:r>
            </a:p>
          </p:txBody>
        </p:sp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91" t="24905" r="2264" b="15067"/>
            <a:stretch/>
          </p:blipFill>
          <p:spPr>
            <a:xfrm>
              <a:off x="5145881" y="2255683"/>
              <a:ext cx="2300288" cy="814388"/>
            </a:xfrm>
            <a:prstGeom prst="rect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50" name="Flowchart: Extract 49"/>
            <p:cNvSpPr/>
            <p:nvPr/>
          </p:nvSpPr>
          <p:spPr>
            <a:xfrm rot="16200000" flipH="1">
              <a:off x="7224237" y="2626166"/>
              <a:ext cx="59635" cy="112196"/>
            </a:xfrm>
            <a:prstGeom prst="flowChartExtract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lowchart: Extract 50"/>
            <p:cNvSpPr/>
            <p:nvPr/>
          </p:nvSpPr>
          <p:spPr>
            <a:xfrm rot="5400000">
              <a:off x="6298125" y="2495258"/>
              <a:ext cx="59635" cy="112196"/>
            </a:xfrm>
            <a:prstGeom prst="flowChartExtract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73" t="19328" r="3014" b="9590"/>
            <a:stretch/>
          </p:blipFill>
          <p:spPr>
            <a:xfrm>
              <a:off x="5153025" y="4300538"/>
              <a:ext cx="2314576" cy="964406"/>
            </a:xfrm>
            <a:prstGeom prst="rect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53" name="Flowchart: Extract 52"/>
            <p:cNvSpPr/>
            <p:nvPr/>
          </p:nvSpPr>
          <p:spPr>
            <a:xfrm rot="16200000" flipH="1">
              <a:off x="6575167" y="4675736"/>
              <a:ext cx="59635" cy="11219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lowchart: Extract 53"/>
            <p:cNvSpPr/>
            <p:nvPr/>
          </p:nvSpPr>
          <p:spPr>
            <a:xfrm rot="16200000" flipH="1">
              <a:off x="7008006" y="4672834"/>
              <a:ext cx="59635" cy="11219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lowchart: Extract 54"/>
            <p:cNvSpPr/>
            <p:nvPr/>
          </p:nvSpPr>
          <p:spPr>
            <a:xfrm rot="16200000" flipH="1">
              <a:off x="6798231" y="4989130"/>
              <a:ext cx="59635" cy="11219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lowchart: Extract 55"/>
            <p:cNvSpPr/>
            <p:nvPr/>
          </p:nvSpPr>
          <p:spPr>
            <a:xfrm rot="16200000" flipH="1">
              <a:off x="7154746" y="4984459"/>
              <a:ext cx="59635" cy="11219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4" t="19825" r="5991" b="6459"/>
            <a:stretch/>
          </p:blipFill>
          <p:spPr>
            <a:xfrm>
              <a:off x="5152650" y="3200400"/>
              <a:ext cx="2293519" cy="1000125"/>
            </a:xfrm>
            <a:prstGeom prst="rect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58" name="Flowchart: Extract 57"/>
            <p:cNvSpPr/>
            <p:nvPr/>
          </p:nvSpPr>
          <p:spPr>
            <a:xfrm rot="16200000" flipH="1">
              <a:off x="5739578" y="3875397"/>
              <a:ext cx="59635" cy="11219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lowchart: Extract 58"/>
            <p:cNvSpPr/>
            <p:nvPr/>
          </p:nvSpPr>
          <p:spPr>
            <a:xfrm rot="16200000" flipH="1">
              <a:off x="6231361" y="3903909"/>
              <a:ext cx="59635" cy="11219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lowchart: Extract 59"/>
            <p:cNvSpPr/>
            <p:nvPr/>
          </p:nvSpPr>
          <p:spPr>
            <a:xfrm rot="16200000">
              <a:off x="5524303" y="3490056"/>
              <a:ext cx="45719" cy="121245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Flowchart: Extract 60"/>
            <p:cNvSpPr/>
            <p:nvPr/>
          </p:nvSpPr>
          <p:spPr>
            <a:xfrm rot="16200000" flipH="1">
              <a:off x="5945660" y="3544355"/>
              <a:ext cx="59635" cy="11219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230623" y="1529779"/>
              <a:ext cx="915635" cy="438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</a:t>
              </a:r>
            </a:p>
            <a:p>
              <a:pPr defTabSz="342900"/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exposure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254080" y="3563258"/>
              <a:ext cx="912429" cy="438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sz="13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  <a:p>
              <a:pPr defTabSz="342900"/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exposure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230623" y="2431691"/>
              <a:ext cx="931665" cy="438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sz="1350" b="1" dirty="0">
                  <a:solidFill>
                    <a:srgbClr val="70AD47">
                      <a:lumMod val="5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</a:t>
              </a:r>
            </a:p>
            <a:p>
              <a:pPr defTabSz="342900"/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hort exposure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254080" y="4521183"/>
              <a:ext cx="931665" cy="438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sz="135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  <a:p>
              <a:pPr defTabSz="342900"/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hort exposure</a:t>
              </a:r>
            </a:p>
          </p:txBody>
        </p:sp>
        <p:sp>
          <p:nvSpPr>
            <p:cNvPr id="68" name="Flowchart: Extract 67"/>
            <p:cNvSpPr/>
            <p:nvPr/>
          </p:nvSpPr>
          <p:spPr>
            <a:xfrm rot="16200000" flipH="1">
              <a:off x="5711439" y="4970917"/>
              <a:ext cx="59635" cy="11219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Flowchart: Extract 68"/>
            <p:cNvSpPr/>
            <p:nvPr/>
          </p:nvSpPr>
          <p:spPr>
            <a:xfrm rot="16200000">
              <a:off x="6213797" y="4958963"/>
              <a:ext cx="45719" cy="8777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342900"/>
              <a:endParaRPr lang="en-US" sz="135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BD7E64DA-9E04-48B1-A988-3026068440CB}"/>
              </a:ext>
            </a:extLst>
          </p:cNvPr>
          <p:cNvGrpSpPr/>
          <p:nvPr/>
        </p:nvGrpSpPr>
        <p:grpSpPr>
          <a:xfrm>
            <a:off x="2718991" y="94935"/>
            <a:ext cx="4542214" cy="6287624"/>
            <a:chOff x="3742428" y="31333"/>
            <a:chExt cx="4542214" cy="6287624"/>
          </a:xfrm>
        </p:grpSpPr>
        <p:grpSp>
          <p:nvGrpSpPr>
            <p:cNvPr id="65" name="Group 64"/>
            <p:cNvGrpSpPr/>
            <p:nvPr/>
          </p:nvGrpSpPr>
          <p:grpSpPr>
            <a:xfrm>
              <a:off x="4067266" y="312278"/>
              <a:ext cx="4197389" cy="1397030"/>
              <a:chOff x="728207" y="621642"/>
              <a:chExt cx="5596519" cy="1862706"/>
            </a:xfrm>
          </p:grpSpPr>
          <p:pic>
            <p:nvPicPr>
              <p:cNvPr id="88" name="Picture 87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0066"/>
              <a:stretch/>
            </p:blipFill>
            <p:spPr>
              <a:xfrm>
                <a:off x="728207" y="621642"/>
                <a:ext cx="3730385" cy="1862706"/>
              </a:xfrm>
              <a:prstGeom prst="rect">
                <a:avLst/>
              </a:prstGeom>
            </p:spPr>
          </p:pic>
          <p:pic>
            <p:nvPicPr>
              <p:cNvPr id="89" name="Picture 88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240" t="50347"/>
              <a:stretch/>
            </p:blipFill>
            <p:spPr>
              <a:xfrm>
                <a:off x="4458015" y="621642"/>
                <a:ext cx="1866711" cy="1862706"/>
              </a:xfrm>
              <a:prstGeom prst="rect">
                <a:avLst/>
              </a:prstGeom>
            </p:spPr>
          </p:pic>
        </p:grpSp>
        <p:grpSp>
          <p:nvGrpSpPr>
            <p:cNvPr id="70" name="Group 69"/>
            <p:cNvGrpSpPr/>
            <p:nvPr/>
          </p:nvGrpSpPr>
          <p:grpSpPr>
            <a:xfrm>
              <a:off x="4067266" y="1828062"/>
              <a:ext cx="4197390" cy="1399771"/>
              <a:chOff x="728207" y="2807304"/>
              <a:chExt cx="5596520" cy="1866361"/>
            </a:xfrm>
          </p:grpSpPr>
          <p:pic>
            <p:nvPicPr>
              <p:cNvPr id="86" name="Picture 85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0093"/>
              <a:stretch/>
            </p:blipFill>
            <p:spPr>
              <a:xfrm>
                <a:off x="728207" y="2807304"/>
                <a:ext cx="3729165" cy="1861100"/>
              </a:xfrm>
              <a:prstGeom prst="rect">
                <a:avLst/>
              </a:prstGeom>
            </p:spPr>
          </p:pic>
          <p:pic>
            <p:nvPicPr>
              <p:cNvPr id="87" name="Picture 86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679" t="49706"/>
              <a:stretch/>
            </p:blipFill>
            <p:spPr>
              <a:xfrm>
                <a:off x="4457373" y="2807304"/>
                <a:ext cx="1867354" cy="1866361"/>
              </a:xfrm>
              <a:prstGeom prst="rect">
                <a:avLst/>
              </a:prstGeom>
            </p:spPr>
          </p:pic>
        </p:grpSp>
        <p:sp>
          <p:nvSpPr>
            <p:cNvPr id="71" name="TextBox 70"/>
            <p:cNvSpPr txBox="1"/>
            <p:nvPr/>
          </p:nvSpPr>
          <p:spPr>
            <a:xfrm>
              <a:off x="4250862" y="31333"/>
              <a:ext cx="366170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 channel           RFP channel            </a:t>
              </a:r>
              <a:r>
                <a:rPr lang="en-US" altLang="zh-CN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sz="135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rged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2952277" y="852414"/>
              <a:ext cx="18573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-GFP + AtPIP2;1-RFP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 rot="16200000">
              <a:off x="3281469" y="2370981"/>
              <a:ext cx="11989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-GFP + RFP</a:t>
              </a:r>
            </a:p>
          </p:txBody>
        </p:sp>
        <p:grpSp>
          <p:nvGrpSpPr>
            <p:cNvPr id="74" name="Group 73"/>
            <p:cNvGrpSpPr/>
            <p:nvPr/>
          </p:nvGrpSpPr>
          <p:grpSpPr>
            <a:xfrm>
              <a:off x="4067266" y="3350495"/>
              <a:ext cx="4217376" cy="1410548"/>
              <a:chOff x="724021" y="4848800"/>
              <a:chExt cx="5623168" cy="1880730"/>
            </a:xfrm>
          </p:grpSpPr>
          <p:pic>
            <p:nvPicPr>
              <p:cNvPr id="84" name="Picture 83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9755"/>
              <a:stretch/>
            </p:blipFill>
            <p:spPr>
              <a:xfrm>
                <a:off x="724021" y="4851592"/>
                <a:ext cx="3729165" cy="1873679"/>
              </a:xfrm>
              <a:prstGeom prst="rect">
                <a:avLst/>
              </a:prstGeom>
            </p:spPr>
          </p:pic>
          <p:pic>
            <p:nvPicPr>
              <p:cNvPr id="85" name="Picture 84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643" t="49914"/>
              <a:stretch/>
            </p:blipFill>
            <p:spPr>
              <a:xfrm>
                <a:off x="4456354" y="4848800"/>
                <a:ext cx="1890835" cy="1880730"/>
              </a:xfrm>
              <a:prstGeom prst="rect">
                <a:avLst/>
              </a:prstGeom>
            </p:spPr>
          </p:pic>
        </p:grpSp>
        <p:grpSp>
          <p:nvGrpSpPr>
            <p:cNvPr id="75" name="Group 74"/>
            <p:cNvGrpSpPr/>
            <p:nvPr/>
          </p:nvGrpSpPr>
          <p:grpSpPr>
            <a:xfrm>
              <a:off x="4067266" y="4902346"/>
              <a:ext cx="4217376" cy="1416611"/>
              <a:chOff x="728204" y="6965663"/>
              <a:chExt cx="5623168" cy="1888815"/>
            </a:xfrm>
          </p:grpSpPr>
          <p:pic>
            <p:nvPicPr>
              <p:cNvPr id="82" name="Picture 81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9670"/>
              <a:stretch/>
            </p:blipFill>
            <p:spPr>
              <a:xfrm>
                <a:off x="728204" y="6965664"/>
                <a:ext cx="3752863" cy="1888814"/>
              </a:xfrm>
              <a:prstGeom prst="rect">
                <a:avLst/>
              </a:prstGeom>
            </p:spPr>
          </p:pic>
          <p:pic>
            <p:nvPicPr>
              <p:cNvPr id="83" name="Picture 82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776" t="49301"/>
              <a:stretch/>
            </p:blipFill>
            <p:spPr>
              <a:xfrm>
                <a:off x="4481067" y="6965663"/>
                <a:ext cx="1870305" cy="1887999"/>
              </a:xfrm>
              <a:prstGeom prst="rect">
                <a:avLst/>
              </a:prstGeom>
            </p:spPr>
          </p:pic>
        </p:grpSp>
        <p:sp>
          <p:nvSpPr>
            <p:cNvPr id="76" name="TextBox 75"/>
            <p:cNvSpPr txBox="1"/>
            <p:nvPr/>
          </p:nvSpPr>
          <p:spPr>
            <a:xfrm rot="16200000">
              <a:off x="2947467" y="3935834"/>
              <a:ext cx="18669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l-GR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-GFP + AtPIP2;1-RFP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3276660" y="5476509"/>
              <a:ext cx="1208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342900"/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ΔN-GFP + RFP</a:t>
              </a:r>
            </a:p>
          </p:txBody>
        </p:sp>
        <p:cxnSp>
          <p:nvCxnSpPr>
            <p:cNvPr id="78" name="Straight Connector 77"/>
            <p:cNvCxnSpPr/>
            <p:nvPr/>
          </p:nvCxnSpPr>
          <p:spPr>
            <a:xfrm>
              <a:off x="7873067" y="4686841"/>
              <a:ext cx="354444" cy="3251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>
              <a:off x="7889397" y="6214729"/>
              <a:ext cx="354444" cy="3251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7875401" y="3149622"/>
              <a:ext cx="354444" cy="3251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7875401" y="1624069"/>
              <a:ext cx="354444" cy="3251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" name="TextBox 89">
            <a:extLst>
              <a:ext uri="{FF2B5EF4-FFF2-40B4-BE49-F238E27FC236}">
                <a16:creationId xmlns:a16="http://schemas.microsoft.com/office/drawing/2014/main" id="{BD50604D-D372-40C4-99E9-48B063A2D7B6}"/>
              </a:ext>
            </a:extLst>
          </p:cNvPr>
          <p:cNvSpPr txBox="1"/>
          <p:nvPr/>
        </p:nvSpPr>
        <p:spPr>
          <a:xfrm>
            <a:off x="2030440" y="14143"/>
            <a:ext cx="44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D50604D-D372-40C4-99E9-48B063A2D7B6}"/>
              </a:ext>
            </a:extLst>
          </p:cNvPr>
          <p:cNvSpPr txBox="1"/>
          <p:nvPr/>
        </p:nvSpPr>
        <p:spPr>
          <a:xfrm>
            <a:off x="7672380" y="0"/>
            <a:ext cx="44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2" name="Rectangle 91"/>
          <p:cNvSpPr/>
          <p:nvPr/>
        </p:nvSpPr>
        <p:spPr>
          <a:xfrm>
            <a:off x="-53708" y="6514127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34752550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8" name="Group 157">
            <a:extLst>
              <a:ext uri="{FF2B5EF4-FFF2-40B4-BE49-F238E27FC236}">
                <a16:creationId xmlns:a16="http://schemas.microsoft.com/office/drawing/2014/main" id="{DFC90A6D-C51E-4E58-AE7D-F51CED9EA8C4}"/>
              </a:ext>
            </a:extLst>
          </p:cNvPr>
          <p:cNvGrpSpPr/>
          <p:nvPr/>
        </p:nvGrpSpPr>
        <p:grpSpPr>
          <a:xfrm>
            <a:off x="7465971" y="62125"/>
            <a:ext cx="4122750" cy="6523946"/>
            <a:chOff x="3657451" y="167027"/>
            <a:chExt cx="4122750" cy="6523946"/>
          </a:xfrm>
        </p:grpSpPr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C027E9A1-E0C2-49A2-91B8-9D9BBE7AC579}"/>
                </a:ext>
              </a:extLst>
            </p:cNvPr>
            <p:cNvGrpSpPr/>
            <p:nvPr/>
          </p:nvGrpSpPr>
          <p:grpSpPr>
            <a:xfrm>
              <a:off x="4953454" y="2536056"/>
              <a:ext cx="2763308" cy="1125423"/>
              <a:chOff x="2136152" y="1668119"/>
              <a:chExt cx="3047021" cy="1240972"/>
            </a:xfrm>
          </p:grpSpPr>
          <p:pic>
            <p:nvPicPr>
              <p:cNvPr id="155" name="Picture 154">
                <a:extLst>
                  <a:ext uri="{FF2B5EF4-FFF2-40B4-BE49-F238E27FC236}">
                    <a16:creationId xmlns:a16="http://schemas.microsoft.com/office/drawing/2014/main" id="{EE386F69-2F2F-41CF-8C5D-D398194EC6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07" t="12891" r="3847" b="18508"/>
              <a:stretch/>
            </p:blipFill>
            <p:spPr>
              <a:xfrm>
                <a:off x="2136152" y="1668119"/>
                <a:ext cx="3047021" cy="1240972"/>
              </a:xfrm>
              <a:prstGeom prst="rect">
                <a:avLst/>
              </a:prstGeom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156" name="Flowchart: Extract 155">
                <a:extLst>
                  <a:ext uri="{FF2B5EF4-FFF2-40B4-BE49-F238E27FC236}">
                    <a16:creationId xmlns:a16="http://schemas.microsoft.com/office/drawing/2014/main" id="{79263659-8910-4C54-A318-0479081333D2}"/>
                  </a:ext>
                </a:extLst>
              </p:cNvPr>
              <p:cNvSpPr/>
              <p:nvPr/>
            </p:nvSpPr>
            <p:spPr>
              <a:xfrm rot="16200000" flipH="1">
                <a:off x="4775363" y="2083227"/>
                <a:ext cx="79513" cy="149594"/>
              </a:xfrm>
              <a:prstGeom prst="flowChartExtra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Flowchart: Extract 156">
                <a:extLst>
                  <a:ext uri="{FF2B5EF4-FFF2-40B4-BE49-F238E27FC236}">
                    <a16:creationId xmlns:a16="http://schemas.microsoft.com/office/drawing/2014/main" id="{0A82BA8F-3455-41BE-9CB3-8C8F88EC4714}"/>
                  </a:ext>
                </a:extLst>
              </p:cNvPr>
              <p:cNvSpPr/>
              <p:nvPr/>
            </p:nvSpPr>
            <p:spPr>
              <a:xfrm rot="5400000">
                <a:off x="3562479" y="2284143"/>
                <a:ext cx="79513" cy="149594"/>
              </a:xfrm>
              <a:prstGeom prst="flowChartExtra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582B3B4-35D6-441B-AD84-43E7DAF40F3B}"/>
                </a:ext>
              </a:extLst>
            </p:cNvPr>
            <p:cNvSpPr txBox="1"/>
            <p:nvPr/>
          </p:nvSpPr>
          <p:spPr>
            <a:xfrm rot="19310695">
              <a:off x="4835171" y="906736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6947AD4E-894E-47FB-B7E8-CFD905406791}"/>
                </a:ext>
              </a:extLst>
            </p:cNvPr>
            <p:cNvSpPr txBox="1"/>
            <p:nvPr/>
          </p:nvSpPr>
          <p:spPr>
            <a:xfrm>
              <a:off x="5070218" y="587381"/>
              <a:ext cx="4956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C9A12CC1-92B2-4A48-9302-ACCFA386D721}"/>
                </a:ext>
              </a:extLst>
            </p:cNvPr>
            <p:cNvCxnSpPr/>
            <p:nvPr/>
          </p:nvCxnSpPr>
          <p:spPr>
            <a:xfrm>
              <a:off x="4898657" y="587381"/>
              <a:ext cx="1384586" cy="7702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BFE3D1C4-1916-44A4-A915-4CEFB6FA28FF}"/>
                </a:ext>
              </a:extLst>
            </p:cNvPr>
            <p:cNvSpPr txBox="1"/>
            <p:nvPr/>
          </p:nvSpPr>
          <p:spPr>
            <a:xfrm>
              <a:off x="3657451" y="592015"/>
              <a:ext cx="1171988" cy="677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 fusion</a:t>
              </a:r>
            </a:p>
            <a:p>
              <a:endPara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 fusion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CB1C9C53-2D83-4196-810B-6F16DEC185C4}"/>
                </a:ext>
              </a:extLst>
            </p:cNvPr>
            <p:cNvSpPr txBox="1"/>
            <p:nvPr/>
          </p:nvSpPr>
          <p:spPr>
            <a:xfrm rot="19310695">
              <a:off x="5073532" y="897479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F9D971FC-E708-4FD9-90D2-825556465449}"/>
                </a:ext>
              </a:extLst>
            </p:cNvPr>
            <p:cNvCxnSpPr/>
            <p:nvPr/>
          </p:nvCxnSpPr>
          <p:spPr>
            <a:xfrm>
              <a:off x="4886430" y="922324"/>
              <a:ext cx="655509" cy="5136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11F169CB-25AD-43EF-9774-5BB4D9609CF4}"/>
                </a:ext>
              </a:extLst>
            </p:cNvPr>
            <p:cNvSpPr txBox="1"/>
            <p:nvPr/>
          </p:nvSpPr>
          <p:spPr>
            <a:xfrm rot="19310695">
              <a:off x="5495009" y="924573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E665913-3CDD-44A7-8404-6A4A032C0CB0}"/>
                </a:ext>
              </a:extLst>
            </p:cNvPr>
            <p:cNvSpPr txBox="1"/>
            <p:nvPr/>
          </p:nvSpPr>
          <p:spPr>
            <a:xfrm>
              <a:off x="5682891" y="591842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13563350-B72C-448E-9904-4F066C95C000}"/>
                </a:ext>
              </a:extLst>
            </p:cNvPr>
            <p:cNvSpPr txBox="1"/>
            <p:nvPr/>
          </p:nvSpPr>
          <p:spPr>
            <a:xfrm rot="19310695">
              <a:off x="5719993" y="915316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9BEC2EC6-1580-4864-B2DA-7DDA106D5880}"/>
                </a:ext>
              </a:extLst>
            </p:cNvPr>
            <p:cNvCxnSpPr/>
            <p:nvPr/>
          </p:nvCxnSpPr>
          <p:spPr>
            <a:xfrm>
              <a:off x="5586390" y="926786"/>
              <a:ext cx="655509" cy="5136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05E8592-E773-4260-ADA0-1751057C125F}"/>
                </a:ext>
              </a:extLst>
            </p:cNvPr>
            <p:cNvSpPr txBox="1"/>
            <p:nvPr/>
          </p:nvSpPr>
          <p:spPr>
            <a:xfrm rot="19310695">
              <a:off x="6265191" y="919836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0A92D675-8DAB-4DDC-9D8E-D4B6EE2FDF9F}"/>
                </a:ext>
              </a:extLst>
            </p:cNvPr>
            <p:cNvSpPr txBox="1"/>
            <p:nvPr/>
          </p:nvSpPr>
          <p:spPr>
            <a:xfrm>
              <a:off x="6502703" y="600481"/>
              <a:ext cx="4956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ACC949BE-8AFC-448E-B64E-1A44DBDE1D47}"/>
                </a:ext>
              </a:extLst>
            </p:cNvPr>
            <p:cNvSpPr txBox="1"/>
            <p:nvPr/>
          </p:nvSpPr>
          <p:spPr>
            <a:xfrm rot="19310695">
              <a:off x="6516927" y="910579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524FCEF9-5507-4A3A-9DFB-DDD45AD8FD4D}"/>
                </a:ext>
              </a:extLst>
            </p:cNvPr>
            <p:cNvCxnSpPr/>
            <p:nvPr/>
          </p:nvCxnSpPr>
          <p:spPr>
            <a:xfrm>
              <a:off x="6329825" y="935424"/>
              <a:ext cx="655509" cy="5136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931A86F9-0B56-4098-8D57-E37C64D23626}"/>
                </a:ext>
              </a:extLst>
            </p:cNvPr>
            <p:cNvSpPr txBox="1"/>
            <p:nvPr/>
          </p:nvSpPr>
          <p:spPr>
            <a:xfrm rot="19310695">
              <a:off x="6884904" y="937673"/>
              <a:ext cx="5148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IP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741DDA75-42B5-4AC7-B5FF-0747B4503D85}"/>
                </a:ext>
              </a:extLst>
            </p:cNvPr>
            <p:cNvSpPr txBox="1"/>
            <p:nvPr/>
          </p:nvSpPr>
          <p:spPr>
            <a:xfrm>
              <a:off x="7115374" y="604942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7A7BD3E0-9550-49F5-8930-C1A5B2C3AAEE}"/>
                </a:ext>
              </a:extLst>
            </p:cNvPr>
            <p:cNvSpPr txBox="1"/>
            <p:nvPr/>
          </p:nvSpPr>
          <p:spPr>
            <a:xfrm rot="19310695">
              <a:off x="7109889" y="928416"/>
              <a:ext cx="5822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</p:txBody>
        </p: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0D66AF78-DF2B-4E05-B140-B3F4E13BA1D7}"/>
                </a:ext>
              </a:extLst>
            </p:cNvPr>
            <p:cNvCxnSpPr/>
            <p:nvPr/>
          </p:nvCxnSpPr>
          <p:spPr>
            <a:xfrm>
              <a:off x="7029786" y="939886"/>
              <a:ext cx="655509" cy="5136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6A90CE9B-9FB8-4972-81B3-C08A988D14D2}"/>
                </a:ext>
              </a:extLst>
            </p:cNvPr>
            <p:cNvSpPr txBox="1"/>
            <p:nvPr/>
          </p:nvSpPr>
          <p:spPr>
            <a:xfrm>
              <a:off x="5293105" y="167027"/>
              <a:ext cx="7360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put</a:t>
              </a:r>
            </a:p>
          </p:txBody>
        </p: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CB05443E-520A-4037-8BDC-78098F698B5D}"/>
                </a:ext>
              </a:extLst>
            </p:cNvPr>
            <p:cNvCxnSpPr/>
            <p:nvPr/>
          </p:nvCxnSpPr>
          <p:spPr>
            <a:xfrm>
              <a:off x="6355429" y="600481"/>
              <a:ext cx="1384586" cy="7702"/>
            </a:xfrm>
            <a:prstGeom prst="line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9191F482-1223-449E-BB19-77B234D0F8EE}"/>
                </a:ext>
              </a:extLst>
            </p:cNvPr>
            <p:cNvSpPr txBox="1"/>
            <p:nvPr/>
          </p:nvSpPr>
          <p:spPr>
            <a:xfrm>
              <a:off x="6749878" y="180127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IP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067107E7-9ABE-404C-B67E-1D8B783438EA}"/>
                </a:ext>
              </a:extLst>
            </p:cNvPr>
            <p:cNvGrpSpPr/>
            <p:nvPr/>
          </p:nvGrpSpPr>
          <p:grpSpPr>
            <a:xfrm>
              <a:off x="4849212" y="1269453"/>
              <a:ext cx="2868060" cy="1140230"/>
              <a:chOff x="2046929" y="3004228"/>
              <a:chExt cx="3162528" cy="1257300"/>
            </a:xfrm>
          </p:grpSpPr>
          <p:pic>
            <p:nvPicPr>
              <p:cNvPr id="152" name="Picture 151">
                <a:extLst>
                  <a:ext uri="{FF2B5EF4-FFF2-40B4-BE49-F238E27FC236}">
                    <a16:creationId xmlns:a16="http://schemas.microsoft.com/office/drawing/2014/main" id="{BF180C06-7128-41A5-B0C8-25845BA9BA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95" t="10465" r="3580" b="20032"/>
              <a:stretch/>
            </p:blipFill>
            <p:spPr>
              <a:xfrm>
                <a:off x="2139684" y="3004228"/>
                <a:ext cx="3069773" cy="1257300"/>
              </a:xfrm>
              <a:prstGeom prst="rect">
                <a:avLst/>
              </a:prstGeom>
              <a:ln w="28575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153" name="Flowchart: Extract 152">
                <a:extLst>
                  <a:ext uri="{FF2B5EF4-FFF2-40B4-BE49-F238E27FC236}">
                    <a16:creationId xmlns:a16="http://schemas.microsoft.com/office/drawing/2014/main" id="{7FA04722-57A0-4999-9293-0BD3C1B438B7}"/>
                  </a:ext>
                </a:extLst>
              </p:cNvPr>
              <p:cNvSpPr/>
              <p:nvPr/>
            </p:nvSpPr>
            <p:spPr>
              <a:xfrm rot="16200000" flipH="1">
                <a:off x="3496399" y="3377077"/>
                <a:ext cx="79513" cy="149594"/>
              </a:xfrm>
              <a:prstGeom prst="flowChartExtra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Flowchart: Extract 153">
                <a:extLst>
                  <a:ext uri="{FF2B5EF4-FFF2-40B4-BE49-F238E27FC236}">
                    <a16:creationId xmlns:a16="http://schemas.microsoft.com/office/drawing/2014/main" id="{67070DB1-0A02-49F9-8BF8-0AD7F83FB318}"/>
                  </a:ext>
                </a:extLst>
              </p:cNvPr>
              <p:cNvSpPr/>
              <p:nvPr/>
            </p:nvSpPr>
            <p:spPr>
              <a:xfrm rot="5400000">
                <a:off x="2081969" y="3823027"/>
                <a:ext cx="79513" cy="149594"/>
              </a:xfrm>
              <a:prstGeom prst="flowChartExtra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B9E2A66A-3891-4826-8F6A-0174A7215994}"/>
                </a:ext>
              </a:extLst>
            </p:cNvPr>
            <p:cNvSpPr txBox="1"/>
            <p:nvPr/>
          </p:nvSpPr>
          <p:spPr>
            <a:xfrm>
              <a:off x="3737553" y="1566146"/>
              <a:ext cx="1159292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</a:t>
              </a:r>
            </a:p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exposure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ACE16CC6-4B0A-4327-9503-5AFF19F9A073}"/>
                </a:ext>
              </a:extLst>
            </p:cNvPr>
            <p:cNvSpPr txBox="1"/>
            <p:nvPr/>
          </p:nvSpPr>
          <p:spPr>
            <a:xfrm>
              <a:off x="3765917" y="4187890"/>
              <a:ext cx="1151726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  <a:p>
              <a:pPr lvl="0"/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ng exposure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59183214-2397-4271-9348-039007841341}"/>
                </a:ext>
              </a:extLst>
            </p:cNvPr>
            <p:cNvSpPr txBox="1"/>
            <p:nvPr/>
          </p:nvSpPr>
          <p:spPr>
            <a:xfrm>
              <a:off x="3737551" y="2632688"/>
              <a:ext cx="117737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b="1" dirty="0">
                  <a:solidFill>
                    <a:schemeClr val="accent6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FP</a:t>
              </a:r>
            </a:p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rt exposure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433D91ED-78CE-45DE-AC49-498D5BDEC9FE}"/>
                </a:ext>
              </a:extLst>
            </p:cNvPr>
            <p:cNvSpPr txBox="1"/>
            <p:nvPr/>
          </p:nvSpPr>
          <p:spPr>
            <a:xfrm>
              <a:off x="3779142" y="5743094"/>
              <a:ext cx="1177374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-</a:t>
              </a:r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FP</a:t>
              </a:r>
            </a:p>
            <a:p>
              <a:pPr lvl="0"/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hort exposure</a:t>
              </a:r>
            </a:p>
          </p:txBody>
        </p:sp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E4D60F8E-7C13-44A6-8C9A-C49E06EAC1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39" t="7685" b="6703"/>
            <a:stretch/>
          </p:blipFill>
          <p:spPr>
            <a:xfrm>
              <a:off x="4937486" y="5286462"/>
              <a:ext cx="2842715" cy="1404511"/>
            </a:xfrm>
            <a:prstGeom prst="rect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35" name="Flowchart: Extract 134">
              <a:extLst>
                <a:ext uri="{FF2B5EF4-FFF2-40B4-BE49-F238E27FC236}">
                  <a16:creationId xmlns:a16="http://schemas.microsoft.com/office/drawing/2014/main" id="{12A9E03E-DAE4-46BC-A4BD-E88249942B16}"/>
                </a:ext>
              </a:extLst>
            </p:cNvPr>
            <p:cNvSpPr/>
            <p:nvPr/>
          </p:nvSpPr>
          <p:spPr>
            <a:xfrm rot="16200000" flipH="1">
              <a:off x="5619260" y="6426039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Flowchart: Extract 135">
              <a:extLst>
                <a:ext uri="{FF2B5EF4-FFF2-40B4-BE49-F238E27FC236}">
                  <a16:creationId xmlns:a16="http://schemas.microsoft.com/office/drawing/2014/main" id="{F5D17375-EB3A-4885-B25A-3E1B7BADCCCE}"/>
                </a:ext>
              </a:extLst>
            </p:cNvPr>
            <p:cNvSpPr/>
            <p:nvPr/>
          </p:nvSpPr>
          <p:spPr>
            <a:xfrm rot="16200000" flipH="1">
              <a:off x="6663520" y="5988378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Flowchart: Extract 136">
              <a:extLst>
                <a:ext uri="{FF2B5EF4-FFF2-40B4-BE49-F238E27FC236}">
                  <a16:creationId xmlns:a16="http://schemas.microsoft.com/office/drawing/2014/main" id="{69627280-7476-4F0D-A71D-0D91BA4CC40F}"/>
                </a:ext>
              </a:extLst>
            </p:cNvPr>
            <p:cNvSpPr/>
            <p:nvPr/>
          </p:nvSpPr>
          <p:spPr>
            <a:xfrm rot="16200000" flipH="1">
              <a:off x="7186901" y="5984871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Flowchart: Extract 137">
              <a:extLst>
                <a:ext uri="{FF2B5EF4-FFF2-40B4-BE49-F238E27FC236}">
                  <a16:creationId xmlns:a16="http://schemas.microsoft.com/office/drawing/2014/main" id="{F69C99C7-9120-4F24-94A1-867372F18B5D}"/>
                </a:ext>
              </a:extLst>
            </p:cNvPr>
            <p:cNvSpPr/>
            <p:nvPr/>
          </p:nvSpPr>
          <p:spPr>
            <a:xfrm rot="16200000" flipH="1">
              <a:off x="6222555" y="6460515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Flowchart: Extract 138">
              <a:extLst>
                <a:ext uri="{FF2B5EF4-FFF2-40B4-BE49-F238E27FC236}">
                  <a16:creationId xmlns:a16="http://schemas.microsoft.com/office/drawing/2014/main" id="{BEA4C5E4-02E8-40C9-9ECB-81A36CEFAA7B}"/>
                </a:ext>
              </a:extLst>
            </p:cNvPr>
            <p:cNvSpPr/>
            <p:nvPr/>
          </p:nvSpPr>
          <p:spPr>
            <a:xfrm rot="16200000" flipH="1">
              <a:off x="5345071" y="5901678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Flowchart: Extract 139">
              <a:extLst>
                <a:ext uri="{FF2B5EF4-FFF2-40B4-BE49-F238E27FC236}">
                  <a16:creationId xmlns:a16="http://schemas.microsoft.com/office/drawing/2014/main" id="{086936E5-679F-48CD-8D0A-81086E01CBF7}"/>
                </a:ext>
              </a:extLst>
            </p:cNvPr>
            <p:cNvSpPr/>
            <p:nvPr/>
          </p:nvSpPr>
          <p:spPr>
            <a:xfrm rot="16200000" flipH="1">
              <a:off x="5881210" y="5936443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Flowchart: Extract 140">
              <a:extLst>
                <a:ext uri="{FF2B5EF4-FFF2-40B4-BE49-F238E27FC236}">
                  <a16:creationId xmlns:a16="http://schemas.microsoft.com/office/drawing/2014/main" id="{63724DC1-FAA0-4707-9D41-7103F522DFA2}"/>
                </a:ext>
              </a:extLst>
            </p:cNvPr>
            <p:cNvSpPr/>
            <p:nvPr/>
          </p:nvSpPr>
          <p:spPr>
            <a:xfrm rot="16200000" flipH="1">
              <a:off x="6971517" y="6443876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Flowchart: Extract 141">
              <a:extLst>
                <a:ext uri="{FF2B5EF4-FFF2-40B4-BE49-F238E27FC236}">
                  <a16:creationId xmlns:a16="http://schemas.microsoft.com/office/drawing/2014/main" id="{B0A29D15-73FB-4D7C-8F39-F0F62DA79359}"/>
                </a:ext>
              </a:extLst>
            </p:cNvPr>
            <p:cNvSpPr/>
            <p:nvPr/>
          </p:nvSpPr>
          <p:spPr>
            <a:xfrm rot="16200000" flipH="1">
              <a:off x="7454439" y="6438228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id="{5E1E60A3-73C3-4BA3-9047-9700CF3B6D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4" t="6725" r="3126" b="9288"/>
            <a:stretch/>
          </p:blipFill>
          <p:spPr>
            <a:xfrm>
              <a:off x="4943070" y="3766547"/>
              <a:ext cx="2783429" cy="1377845"/>
            </a:xfrm>
            <a:prstGeom prst="rect">
              <a:avLst/>
            </a:prstGeom>
            <a:ln w="285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44" name="Flowchart: Extract 143">
              <a:extLst>
                <a:ext uri="{FF2B5EF4-FFF2-40B4-BE49-F238E27FC236}">
                  <a16:creationId xmlns:a16="http://schemas.microsoft.com/office/drawing/2014/main" id="{5483E5AB-83D3-457A-9B55-CE5769BE4F55}"/>
                </a:ext>
              </a:extLst>
            </p:cNvPr>
            <p:cNvSpPr/>
            <p:nvPr/>
          </p:nvSpPr>
          <p:spPr>
            <a:xfrm rot="16200000" flipH="1">
              <a:off x="5672715" y="4917257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Flowchart: Extract 144">
              <a:extLst>
                <a:ext uri="{FF2B5EF4-FFF2-40B4-BE49-F238E27FC236}">
                  <a16:creationId xmlns:a16="http://schemas.microsoft.com/office/drawing/2014/main" id="{72212690-5244-47E2-A96D-AEB88E1BBAD4}"/>
                </a:ext>
              </a:extLst>
            </p:cNvPr>
            <p:cNvSpPr/>
            <p:nvPr/>
          </p:nvSpPr>
          <p:spPr>
            <a:xfrm rot="16200000" flipH="1">
              <a:off x="6716973" y="4479595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Flowchart: Extract 145">
              <a:extLst>
                <a:ext uri="{FF2B5EF4-FFF2-40B4-BE49-F238E27FC236}">
                  <a16:creationId xmlns:a16="http://schemas.microsoft.com/office/drawing/2014/main" id="{4B5C4AA4-A252-4531-92C6-BF2BD9A12D22}"/>
                </a:ext>
              </a:extLst>
            </p:cNvPr>
            <p:cNvSpPr/>
            <p:nvPr/>
          </p:nvSpPr>
          <p:spPr>
            <a:xfrm rot="16200000" flipH="1">
              <a:off x="7240356" y="4476085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Flowchart: Extract 146">
              <a:extLst>
                <a:ext uri="{FF2B5EF4-FFF2-40B4-BE49-F238E27FC236}">
                  <a16:creationId xmlns:a16="http://schemas.microsoft.com/office/drawing/2014/main" id="{7967DD21-C861-4913-ABA3-92F816E3F486}"/>
                </a:ext>
              </a:extLst>
            </p:cNvPr>
            <p:cNvSpPr/>
            <p:nvPr/>
          </p:nvSpPr>
          <p:spPr>
            <a:xfrm rot="16200000" flipH="1">
              <a:off x="6276010" y="4951733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Flowchart: Extract 147">
              <a:extLst>
                <a:ext uri="{FF2B5EF4-FFF2-40B4-BE49-F238E27FC236}">
                  <a16:creationId xmlns:a16="http://schemas.microsoft.com/office/drawing/2014/main" id="{7BDBC912-063A-4738-A9CD-FCF2D0E7065A}"/>
                </a:ext>
              </a:extLst>
            </p:cNvPr>
            <p:cNvSpPr/>
            <p:nvPr/>
          </p:nvSpPr>
          <p:spPr>
            <a:xfrm rot="16200000" flipH="1">
              <a:off x="5398524" y="4392893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Flowchart: Extract 148">
              <a:extLst>
                <a:ext uri="{FF2B5EF4-FFF2-40B4-BE49-F238E27FC236}">
                  <a16:creationId xmlns:a16="http://schemas.microsoft.com/office/drawing/2014/main" id="{CC46C685-BB74-457E-B7B7-E6E391892581}"/>
                </a:ext>
              </a:extLst>
            </p:cNvPr>
            <p:cNvSpPr/>
            <p:nvPr/>
          </p:nvSpPr>
          <p:spPr>
            <a:xfrm rot="16200000" flipH="1">
              <a:off x="5934665" y="4427661"/>
              <a:ext cx="72109" cy="135666"/>
            </a:xfrm>
            <a:prstGeom prst="flowChartExtra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Flowchart: Extract 149">
              <a:extLst>
                <a:ext uri="{FF2B5EF4-FFF2-40B4-BE49-F238E27FC236}">
                  <a16:creationId xmlns:a16="http://schemas.microsoft.com/office/drawing/2014/main" id="{3E594F59-99A7-44F1-9EA7-48181CCC6E73}"/>
                </a:ext>
              </a:extLst>
            </p:cNvPr>
            <p:cNvSpPr/>
            <p:nvPr/>
          </p:nvSpPr>
          <p:spPr>
            <a:xfrm rot="16200000" flipH="1">
              <a:off x="7024973" y="4935093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Flowchart: Extract 150">
              <a:extLst>
                <a:ext uri="{FF2B5EF4-FFF2-40B4-BE49-F238E27FC236}">
                  <a16:creationId xmlns:a16="http://schemas.microsoft.com/office/drawing/2014/main" id="{D01B48AC-BBDC-42B6-8EE6-5038AB19171E}"/>
                </a:ext>
              </a:extLst>
            </p:cNvPr>
            <p:cNvSpPr/>
            <p:nvPr/>
          </p:nvSpPr>
          <p:spPr>
            <a:xfrm rot="16200000" flipH="1">
              <a:off x="7507895" y="4929445"/>
              <a:ext cx="72109" cy="135666"/>
            </a:xfrm>
            <a:prstGeom prst="flowChartExtra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1FACB4FF-A2A1-4D03-98BD-AA86D832C680}"/>
              </a:ext>
            </a:extLst>
          </p:cNvPr>
          <p:cNvGrpSpPr/>
          <p:nvPr/>
        </p:nvGrpSpPr>
        <p:grpSpPr>
          <a:xfrm>
            <a:off x="950257" y="-97025"/>
            <a:ext cx="4936234" cy="6762782"/>
            <a:chOff x="3441809" y="53895"/>
            <a:chExt cx="4936234" cy="6762782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B5FD1F8-FF82-49D6-B168-083616B091A7}"/>
                </a:ext>
              </a:extLst>
            </p:cNvPr>
            <p:cNvSpPr txBox="1"/>
            <p:nvPr/>
          </p:nvSpPr>
          <p:spPr>
            <a:xfrm>
              <a:off x="4145658" y="53895"/>
              <a:ext cx="39464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P channel          RFP channel               merged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E9EA980-E557-4C50-8CF8-BA005ECBCEF7}"/>
                </a:ext>
              </a:extLst>
            </p:cNvPr>
            <p:cNvSpPr txBox="1"/>
            <p:nvPr/>
          </p:nvSpPr>
          <p:spPr>
            <a:xfrm rot="16200000">
              <a:off x="2638609" y="963372"/>
              <a:ext cx="18834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-GFP + OsPIP2;1-RFP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2CC49102-C642-4FB6-8D76-B202D9A94033}"/>
                </a:ext>
              </a:extLst>
            </p:cNvPr>
            <p:cNvSpPr txBox="1"/>
            <p:nvPr/>
          </p:nvSpPr>
          <p:spPr>
            <a:xfrm rot="16200000">
              <a:off x="2980851" y="2586139"/>
              <a:ext cx="11989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-GFP + RFP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760DC31-E518-4389-84AA-61684AA000E2}"/>
                </a:ext>
              </a:extLst>
            </p:cNvPr>
            <p:cNvSpPr txBox="1"/>
            <p:nvPr/>
          </p:nvSpPr>
          <p:spPr>
            <a:xfrm rot="16200000">
              <a:off x="2626589" y="4280549"/>
              <a:ext cx="19074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-GFP + OsPIP2;1-RFP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85B71768-0D92-4AB0-882D-CEAE2520F3AF}"/>
                </a:ext>
              </a:extLst>
            </p:cNvPr>
            <p:cNvSpPr txBox="1"/>
            <p:nvPr/>
          </p:nvSpPr>
          <p:spPr>
            <a:xfrm rot="16200000">
              <a:off x="2968827" y="5948779"/>
              <a:ext cx="1222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-GFP + RFP</a:t>
              </a:r>
            </a:p>
          </p:txBody>
        </p:sp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0FEB9065-95D6-4EF6-ABAC-D75E2FD72F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0179"/>
            <a:stretch/>
          </p:blipFill>
          <p:spPr>
            <a:xfrm>
              <a:off x="3782076" y="369343"/>
              <a:ext cx="3028434" cy="1508789"/>
            </a:xfrm>
            <a:prstGeom prst="rect">
              <a:avLst/>
            </a:prstGeom>
          </p:spPr>
        </p:pic>
        <p:pic>
          <p:nvPicPr>
            <p:cNvPr id="79" name="Picture 78">
              <a:extLst>
                <a:ext uri="{FF2B5EF4-FFF2-40B4-BE49-F238E27FC236}">
                  <a16:creationId xmlns:a16="http://schemas.microsoft.com/office/drawing/2014/main" id="{35FBB17E-D6B1-4999-ACD0-06DCE5B82F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93" t="49892"/>
            <a:stretch/>
          </p:blipFill>
          <p:spPr>
            <a:xfrm>
              <a:off x="6802845" y="369342"/>
              <a:ext cx="1514192" cy="1511199"/>
            </a:xfrm>
            <a:prstGeom prst="rect">
              <a:avLst/>
            </a:prstGeom>
          </p:spPr>
        </p:pic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C506A2D1-F844-41CC-8943-2850BDF74BBB}"/>
                </a:ext>
              </a:extLst>
            </p:cNvPr>
            <p:cNvCxnSpPr/>
            <p:nvPr/>
          </p:nvCxnSpPr>
          <p:spPr>
            <a:xfrm>
              <a:off x="7885617" y="1765927"/>
              <a:ext cx="383789" cy="352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400DF41D-DAA6-4533-A7BC-C2841EB1A6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9677"/>
            <a:stretch/>
          </p:blipFill>
          <p:spPr>
            <a:xfrm>
              <a:off x="3784408" y="2004308"/>
              <a:ext cx="3028434" cy="1523985"/>
            </a:xfrm>
            <a:prstGeom prst="rect">
              <a:avLst/>
            </a:prstGeom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6B5786C6-E99E-494D-8CE4-D337D4E862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426" t="49677"/>
            <a:stretch/>
          </p:blipFill>
          <p:spPr>
            <a:xfrm>
              <a:off x="6807093" y="2004308"/>
              <a:ext cx="1531586" cy="1523985"/>
            </a:xfrm>
            <a:prstGeom prst="rect">
              <a:avLst/>
            </a:prstGeom>
          </p:spPr>
        </p:pic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CB3029BF-4E9D-4DC0-8B7C-52A71697FDC5}"/>
                </a:ext>
              </a:extLst>
            </p:cNvPr>
            <p:cNvCxnSpPr/>
            <p:nvPr/>
          </p:nvCxnSpPr>
          <p:spPr>
            <a:xfrm>
              <a:off x="7895556" y="3417781"/>
              <a:ext cx="383789" cy="352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E53DE7D5-850A-4A7F-8C3A-5BDAABA466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0172"/>
            <a:stretch/>
          </p:blipFill>
          <p:spPr>
            <a:xfrm>
              <a:off x="3789505" y="3640695"/>
              <a:ext cx="3021005" cy="1505286"/>
            </a:xfrm>
            <a:prstGeom prst="rect">
              <a:avLst/>
            </a:prstGeom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26189BED-7C33-4CB4-9FD0-29A772A361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698" t="52551" r="215" b="-2795"/>
            <a:stretch/>
          </p:blipFill>
          <p:spPr>
            <a:xfrm>
              <a:off x="6797595" y="3630756"/>
              <a:ext cx="1580448" cy="1617687"/>
            </a:xfrm>
            <a:prstGeom prst="rect">
              <a:avLst/>
            </a:prstGeom>
          </p:spPr>
        </p:pic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DB8B534C-8698-4496-B953-7F3D04012959}"/>
                </a:ext>
              </a:extLst>
            </p:cNvPr>
            <p:cNvCxnSpPr/>
            <p:nvPr/>
          </p:nvCxnSpPr>
          <p:spPr>
            <a:xfrm>
              <a:off x="7922846" y="5072331"/>
              <a:ext cx="383789" cy="352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BB8F8143-A6BA-446F-85B5-5D985C8BDE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28" t="50661"/>
            <a:stretch/>
          </p:blipFill>
          <p:spPr>
            <a:xfrm>
              <a:off x="6813691" y="5285008"/>
              <a:ext cx="1554412" cy="1531669"/>
            </a:xfrm>
            <a:prstGeom prst="rect">
              <a:avLst/>
            </a:prstGeom>
          </p:spPr>
        </p:pic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32DFD5B9-AB58-473A-AD6A-A656F395C2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9964"/>
            <a:stretch/>
          </p:blipFill>
          <p:spPr>
            <a:xfrm>
              <a:off x="3789505" y="5288444"/>
              <a:ext cx="3029152" cy="1515661"/>
            </a:xfrm>
            <a:prstGeom prst="rect">
              <a:avLst/>
            </a:prstGeom>
          </p:spPr>
        </p:pic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3DEBD7E3-FC08-4D62-9D30-BC46E9F0116C}"/>
                </a:ext>
              </a:extLst>
            </p:cNvPr>
            <p:cNvCxnSpPr/>
            <p:nvPr/>
          </p:nvCxnSpPr>
          <p:spPr>
            <a:xfrm>
              <a:off x="7920648" y="6736652"/>
              <a:ext cx="383789" cy="352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" name="TextBox 89">
            <a:extLst>
              <a:ext uri="{FF2B5EF4-FFF2-40B4-BE49-F238E27FC236}">
                <a16:creationId xmlns:a16="http://schemas.microsoft.com/office/drawing/2014/main" id="{BD50604D-D372-40C4-99E9-48B063A2D7B6}"/>
              </a:ext>
            </a:extLst>
          </p:cNvPr>
          <p:cNvSpPr txBox="1"/>
          <p:nvPr/>
        </p:nvSpPr>
        <p:spPr>
          <a:xfrm>
            <a:off x="523409" y="-39060"/>
            <a:ext cx="44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D50604D-D372-40C4-99E9-48B063A2D7B6}"/>
              </a:ext>
            </a:extLst>
          </p:cNvPr>
          <p:cNvSpPr txBox="1"/>
          <p:nvPr/>
        </p:nvSpPr>
        <p:spPr>
          <a:xfrm>
            <a:off x="7672380" y="0"/>
            <a:ext cx="44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2" name="Rectangle 91"/>
          <p:cNvSpPr/>
          <p:nvPr/>
        </p:nvSpPr>
        <p:spPr>
          <a:xfrm>
            <a:off x="-53708" y="6514127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0063126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83CC62A-E11C-468D-A4D3-F9884E3871F7}"/>
              </a:ext>
            </a:extLst>
          </p:cNvPr>
          <p:cNvGrpSpPr/>
          <p:nvPr/>
        </p:nvGrpSpPr>
        <p:grpSpPr>
          <a:xfrm>
            <a:off x="1232452" y="1248564"/>
            <a:ext cx="8749452" cy="3842266"/>
            <a:chOff x="1232452" y="1248564"/>
            <a:chExt cx="8749452" cy="3842266"/>
          </a:xfrm>
        </p:grpSpPr>
        <p:sp>
          <p:nvSpPr>
            <p:cNvPr id="12" name="TextBox 11"/>
            <p:cNvSpPr txBox="1"/>
            <p:nvPr/>
          </p:nvSpPr>
          <p:spPr>
            <a:xfrm>
              <a:off x="2384543" y="1248564"/>
              <a:ext cx="204386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proSARK:GUS(+)</a:t>
              </a: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6426" y="1632194"/>
              <a:ext cx="2211980" cy="1658985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6205" y="3331694"/>
              <a:ext cx="2222201" cy="166665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DFBD3AF-1116-4C72-8693-02B119075081}"/>
                </a:ext>
              </a:extLst>
            </p:cNvPr>
            <p:cNvSpPr txBox="1"/>
            <p:nvPr/>
          </p:nvSpPr>
          <p:spPr>
            <a:xfrm>
              <a:off x="1232452" y="2273322"/>
              <a:ext cx="9737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F4203A3-6F49-452D-953C-BF0387B54EC6}"/>
                </a:ext>
              </a:extLst>
            </p:cNvPr>
            <p:cNvSpPr txBox="1"/>
            <p:nvPr/>
          </p:nvSpPr>
          <p:spPr>
            <a:xfrm>
              <a:off x="1503270" y="3833678"/>
              <a:ext cx="862241" cy="376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salt</a:t>
              </a:r>
              <a:endPara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3BC17A9-0C9D-4496-80E5-DD0FFBCD6CA6}"/>
                </a:ext>
              </a:extLst>
            </p:cNvPr>
            <p:cNvSpPr txBox="1"/>
            <p:nvPr/>
          </p:nvSpPr>
          <p:spPr>
            <a:xfrm>
              <a:off x="1281725" y="1274197"/>
              <a:ext cx="44308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CCC4E15-C78A-4554-AA6B-3B8A8AD75E03}"/>
                </a:ext>
              </a:extLst>
            </p:cNvPr>
            <p:cNvSpPr txBox="1"/>
            <p:nvPr/>
          </p:nvSpPr>
          <p:spPr>
            <a:xfrm>
              <a:off x="4520644" y="1274197"/>
              <a:ext cx="44308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7C4436D-86B0-4CEE-B17A-6DE2AB6BA8C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438949" y="1433230"/>
              <a:ext cx="5542955" cy="3657600"/>
            </a:xfrm>
            <a:prstGeom prst="rect">
              <a:avLst/>
            </a:prstGeom>
          </p:spPr>
        </p:pic>
      </p:grpSp>
      <p:sp>
        <p:nvSpPr>
          <p:cNvPr id="11" name="Rectangle 10"/>
          <p:cNvSpPr/>
          <p:nvPr/>
        </p:nvSpPr>
        <p:spPr>
          <a:xfrm>
            <a:off x="310040" y="6153789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21248680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10040" y="6153789"/>
            <a:ext cx="10424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ure S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D22DD4F-91E5-4D3C-A8D3-A805FEFE5B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8029" y="1574267"/>
            <a:ext cx="5777316" cy="39259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4837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164</Words>
  <Application>Microsoft Macintosh PowerPoint</Application>
  <PresentationFormat>Widescreen</PresentationFormat>
  <Paragraphs>103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r Sade</dc:creator>
  <cp:lastModifiedBy>Eduardo Blumwald</cp:lastModifiedBy>
  <cp:revision>4</cp:revision>
  <dcterms:created xsi:type="dcterms:W3CDTF">2020-09-27T10:04:20Z</dcterms:created>
  <dcterms:modified xsi:type="dcterms:W3CDTF">2020-10-18T17:55:34Z</dcterms:modified>
</cp:coreProperties>
</file>